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0" d="100"/>
          <a:sy n="90" d="100"/>
        </p:scale>
        <p:origin x="82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AB99A2A-8123-C91D-E382-0E3F912E176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E804F34-5B0F-D204-574F-E90D019E5D6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3ED3588-F827-5CD6-C4B2-274D21C29D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77EE1-66F0-43DD-8F14-10F3A3A065D0}" type="datetimeFigureOut">
              <a:rPr lang="zh-CN" altLang="en-US" smtClean="0"/>
              <a:t>2024/8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AABC128-D6F9-6CF0-352A-C12182B89B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57C517-59FC-6137-B021-7643858231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F6DC3-A056-4F73-8A05-939C0A1E9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42130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4DA0B95-A79F-E4A5-FB74-9288025072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DE03D94-1D34-E54D-180D-8B4F489EA2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2B651D8-3995-C09F-4507-956825BE3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77EE1-66F0-43DD-8F14-10F3A3A065D0}" type="datetimeFigureOut">
              <a:rPr lang="zh-CN" altLang="en-US" smtClean="0"/>
              <a:t>2024/8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463E4E9-8D0A-055D-F96E-36615B4E2A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D8E0AEF-85E1-9B72-08F0-4B6C55F53F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F6DC3-A056-4F73-8A05-939C0A1E9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74678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FCDB078-307E-5D42-7FCE-D3861507AE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66DE201-7D2C-5BED-9701-7E1B61790E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B294E11-3A09-A13D-1A46-F0ED8E1B01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77EE1-66F0-43DD-8F14-10F3A3A065D0}" type="datetimeFigureOut">
              <a:rPr lang="zh-CN" altLang="en-US" smtClean="0"/>
              <a:t>2024/8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D33D952-842C-725B-F91F-6ED9F8B533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5C041C-465B-86CE-6AF4-342759CE49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F6DC3-A056-4F73-8A05-939C0A1E9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08423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10F392-BB00-B897-0635-FAAC82CDC7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CD02A3D-A3BD-D30E-928D-D4364765ECF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A18E1EB-0117-9140-EDF8-D9DB28C9DC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77EE1-66F0-43DD-8F14-10F3A3A065D0}" type="datetimeFigureOut">
              <a:rPr lang="zh-CN" altLang="en-US" smtClean="0"/>
              <a:t>2024/8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BAE830A-BCBB-52B1-0241-DED61807DA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46DE392-60D1-0DFF-6567-960FF9856B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F6DC3-A056-4F73-8A05-939C0A1E9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73579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0BDAA88-5222-794A-FE79-737A25CFA2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91116CA-DC5B-DCE5-6A24-667B113543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467446-4FAC-37C6-4E58-38B1C28911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77EE1-66F0-43DD-8F14-10F3A3A065D0}" type="datetimeFigureOut">
              <a:rPr lang="zh-CN" altLang="en-US" smtClean="0"/>
              <a:t>2024/8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F2D9840-B5C5-7C00-82A0-1EED88026F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8092B11-332B-F7C0-1DD0-20C482DF22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F6DC3-A056-4F73-8A05-939C0A1E9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9249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F87727-2122-276D-CDFB-D0E18ECBA1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59DAD23-0839-68CA-0D4E-C6E04724D6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1AD9C28-9A90-8CDF-6454-3C4B5FBFE2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D4DDE60-F3AF-5F6F-AA28-258D2A12E4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77EE1-66F0-43DD-8F14-10F3A3A065D0}" type="datetimeFigureOut">
              <a:rPr lang="zh-CN" altLang="en-US" smtClean="0"/>
              <a:t>2024/8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E9044D5-D9F4-D4B6-E39E-185B9B2A4F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A5EB1DF-D781-4F93-C884-D37A1C4416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F6DC3-A056-4F73-8A05-939C0A1E9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4697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ED1CDC2-AD7D-578E-211C-F9942F5A55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9B2FCAB-EE5E-A63E-834E-CF6A2CEA78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4DE8383-AACC-3B42-7B16-9BC54DC227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0949604-B2B9-4DEA-6ED8-0C58D72F90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19E902B-097B-DD4E-1CCB-D02335BE1F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16D7C93-A37E-9F17-C852-D01DF7959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77EE1-66F0-43DD-8F14-10F3A3A065D0}" type="datetimeFigureOut">
              <a:rPr lang="zh-CN" altLang="en-US" smtClean="0"/>
              <a:t>2024/8/3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50EA5D9-389C-81A0-4F19-1E7A09EC0F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2A2CF30-5752-29D0-5995-005DFEA6C8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F6DC3-A056-4F73-8A05-939C0A1E9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0742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52E5E8-C977-752F-D42B-16EA52DB8E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C0B35C7-02AD-AAAD-FB5C-B3B4E54EF1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77EE1-66F0-43DD-8F14-10F3A3A065D0}" type="datetimeFigureOut">
              <a:rPr lang="zh-CN" altLang="en-US" smtClean="0"/>
              <a:t>2024/8/3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0EAC8F9-9ED6-11CD-1DAE-95D0ED99E7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984BA4B-1DF1-B712-B265-F9ABC74296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F6DC3-A056-4F73-8A05-939C0A1E9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01350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03FB569-166B-09F9-23D1-17C714AFC9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77EE1-66F0-43DD-8F14-10F3A3A065D0}" type="datetimeFigureOut">
              <a:rPr lang="zh-CN" altLang="en-US" smtClean="0"/>
              <a:t>2024/8/3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A2C831A-913E-E327-C7DD-2B40CE3761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27239CE-5B81-D2F9-88A1-C78EE5C110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F6DC3-A056-4F73-8A05-939C0A1E9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93156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9282162-2147-00B5-BC19-A107F69CC1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689F90C-A12E-C479-F782-E8A0D3318E9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24C02DC-2880-ED32-DCCB-7FF370EDD8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37C441F-50D3-4B2C-5D45-650EC690A2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77EE1-66F0-43DD-8F14-10F3A3A065D0}" type="datetimeFigureOut">
              <a:rPr lang="zh-CN" altLang="en-US" smtClean="0"/>
              <a:t>2024/8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8CEF21B-3AE5-4BA9-7725-F336AC392A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1285BB5-E811-E880-B28B-1B28EF6DA0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F6DC3-A056-4F73-8A05-939C0A1E9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4150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E68A3F-E0CA-6488-79D6-0049E26FB4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287C9D6-476B-F34C-25CB-2EDB6503A47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BD704A8-B713-2577-0279-2A5DF00EE2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282B919-B74C-9940-A34A-0CBDFB053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77EE1-66F0-43DD-8F14-10F3A3A065D0}" type="datetimeFigureOut">
              <a:rPr lang="zh-CN" altLang="en-US" smtClean="0"/>
              <a:t>2024/8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929967D-7E8C-63D3-B9F4-B1F23944F6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53555D1-36DA-1EB4-E31A-71ED0ABFCC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F6DC3-A056-4F73-8A05-939C0A1E9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61836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4DD16D3-5656-FCB1-29DC-73399EB4F9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4A71E44-C968-788B-55D3-46347E1EC9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D7C6D18-A312-6408-61B1-82C3B33723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B477EE1-66F0-43DD-8F14-10F3A3A065D0}" type="datetimeFigureOut">
              <a:rPr lang="zh-CN" altLang="en-US" smtClean="0"/>
              <a:t>2024/8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601E808-9268-5903-6C1E-48F2231E69A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511CD27-88ED-2BDD-E914-AF209A4DA43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42F6DC3-A056-4F73-8A05-939C0A1E9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02805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0B140E1E-A44C-57FE-A4F7-76D578536238}"/>
              </a:ext>
            </a:extLst>
          </p:cNvPr>
          <p:cNvSpPr txBox="1"/>
          <p:nvPr/>
        </p:nvSpPr>
        <p:spPr>
          <a:xfrm>
            <a:off x="1" y="21004"/>
            <a:ext cx="554731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Exposure: knee pain, outcome: Leg pain on walking</a:t>
            </a:r>
            <a:endParaRPr lang="zh-CN" altLang="en-US" sz="1100" dirty="0"/>
          </a:p>
        </p:txBody>
      </p:sp>
      <p:pic>
        <p:nvPicPr>
          <p:cNvPr id="8" name="图片 7" descr="图表&#10;&#10;描述已自动生成">
            <a:extLst>
              <a:ext uri="{FF2B5EF4-FFF2-40B4-BE49-F238E27FC236}">
                <a16:creationId xmlns:a16="http://schemas.microsoft.com/office/drawing/2014/main" id="{5D0AF523-6027-024B-AF1F-D80D643DB10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1058" y="411484"/>
            <a:ext cx="3154566" cy="2896654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图片 8" descr="图表, 散点图&#10;&#10;描述已自动生成">
            <a:extLst>
              <a:ext uri="{FF2B5EF4-FFF2-40B4-BE49-F238E27FC236}">
                <a16:creationId xmlns:a16="http://schemas.microsoft.com/office/drawing/2014/main" id="{E5BB9164-8EAB-9D92-2D83-8A287916C66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55004" y="411484"/>
            <a:ext cx="3446757" cy="3165084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图片 9" descr="图表&#10;&#10;描述已自动生成">
            <a:extLst>
              <a:ext uri="{FF2B5EF4-FFF2-40B4-BE49-F238E27FC236}">
                <a16:creationId xmlns:a16="http://schemas.microsoft.com/office/drawing/2014/main" id="{ABC035C1-C9C1-AFA8-2870-A21F14F4399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6014" y="3673563"/>
            <a:ext cx="3329610" cy="3056845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图片 10" descr="图表, 散点图&#10;&#10;描述已自动生成">
            <a:extLst>
              <a:ext uri="{FF2B5EF4-FFF2-40B4-BE49-F238E27FC236}">
                <a16:creationId xmlns:a16="http://schemas.microsoft.com/office/drawing/2014/main" id="{BD0111FD-B691-32A3-5C92-6AC8B5E24055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0" y="3871469"/>
            <a:ext cx="3020731" cy="2773879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1262494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1" name="Rectangle 10">
            <a:extLst>
              <a:ext uri="{FF2B5EF4-FFF2-40B4-BE49-F238E27FC236}">
                <a16:creationId xmlns:a16="http://schemas.microsoft.com/office/drawing/2014/main" id="{72018E1B-E0B9-4440-AFF3-4112E50A276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A5D359C-3D2F-DD3B-4059-40EFC335415A}"/>
              </a:ext>
            </a:extLst>
          </p:cNvPr>
          <p:cNvSpPr txBox="1"/>
          <p:nvPr/>
        </p:nvSpPr>
        <p:spPr>
          <a:xfrm>
            <a:off x="0" y="0"/>
            <a:ext cx="60960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Exposure: Leg pain on walking, outcome: knee pain</a:t>
            </a:r>
            <a:endParaRPr lang="zh-CN" altLang="en-US" sz="1100" dirty="0"/>
          </a:p>
        </p:txBody>
      </p:sp>
      <p:pic>
        <p:nvPicPr>
          <p:cNvPr id="12" name="图片 11" descr="图表&#10;&#10;描述已自动生成">
            <a:extLst>
              <a:ext uri="{FF2B5EF4-FFF2-40B4-BE49-F238E27FC236}">
                <a16:creationId xmlns:a16="http://schemas.microsoft.com/office/drawing/2014/main" id="{D83BAC66-ADF3-3C12-8BFF-EF77FD7611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30789" y="342775"/>
            <a:ext cx="3177617" cy="2862879"/>
          </a:xfrm>
          <a:prstGeom prst="rect">
            <a:avLst/>
          </a:prstGeom>
          <a:noFill/>
          <a:ln>
            <a:noFill/>
          </a:ln>
        </p:spPr>
      </p:pic>
      <p:pic>
        <p:nvPicPr>
          <p:cNvPr id="13" name="图片 12" descr="图片包含 表格&#10;&#10;描述已自动生成">
            <a:extLst>
              <a:ext uri="{FF2B5EF4-FFF2-40B4-BE49-F238E27FC236}">
                <a16:creationId xmlns:a16="http://schemas.microsoft.com/office/drawing/2014/main" id="{823980FF-1F65-C49A-4E3C-089953EE14C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45473" y="496185"/>
            <a:ext cx="3589998" cy="3234617"/>
          </a:xfrm>
          <a:prstGeom prst="rect">
            <a:avLst/>
          </a:prstGeom>
          <a:noFill/>
          <a:ln>
            <a:noFill/>
          </a:ln>
        </p:spPr>
      </p:pic>
      <p:pic>
        <p:nvPicPr>
          <p:cNvPr id="14" name="图片 13" descr="表格&#10;&#10;描述已自动生成">
            <a:extLst>
              <a:ext uri="{FF2B5EF4-FFF2-40B4-BE49-F238E27FC236}">
                <a16:creationId xmlns:a16="http://schemas.microsoft.com/office/drawing/2014/main" id="{488CC212-268F-BFA2-E987-9377F6193CE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58369" y="3286819"/>
            <a:ext cx="3801145" cy="3424946"/>
          </a:xfrm>
          <a:prstGeom prst="rect">
            <a:avLst/>
          </a:prstGeom>
          <a:noFill/>
          <a:ln>
            <a:noFill/>
          </a:ln>
        </p:spPr>
      </p:pic>
      <p:pic>
        <p:nvPicPr>
          <p:cNvPr id="15" name="图片 14" descr="图表, 散点图&#10;&#10;描述已自动生成">
            <a:extLst>
              <a:ext uri="{FF2B5EF4-FFF2-40B4-BE49-F238E27FC236}">
                <a16:creationId xmlns:a16="http://schemas.microsoft.com/office/drawing/2014/main" id="{0EB5B3A5-A36F-48D4-3B0D-5BB023DEDDD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4474" y="3701247"/>
            <a:ext cx="3247999" cy="2926321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6071001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1EDF80D1-D806-A604-2B50-E98428ED3FEE}"/>
              </a:ext>
            </a:extLst>
          </p:cNvPr>
          <p:cNvSpPr txBox="1"/>
          <p:nvPr/>
        </p:nvSpPr>
        <p:spPr>
          <a:xfrm>
            <a:off x="0" y="0"/>
            <a:ext cx="60960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Exposure: knee pain, outcome: </a:t>
            </a:r>
            <a:r>
              <a:rPr lang="en-US" altLang="zh-CN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M15 </a:t>
            </a:r>
            <a:r>
              <a:rPr lang="en-US" altLang="zh-CN" sz="1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Polyarthrosis</a:t>
            </a:r>
            <a:endParaRPr lang="zh-CN" altLang="en-US" sz="1100" dirty="0"/>
          </a:p>
        </p:txBody>
      </p:sp>
      <p:pic>
        <p:nvPicPr>
          <p:cNvPr id="3" name="图片 2" descr="图表&#10;&#10;描述已自动生成">
            <a:extLst>
              <a:ext uri="{FF2B5EF4-FFF2-40B4-BE49-F238E27FC236}">
                <a16:creationId xmlns:a16="http://schemas.microsoft.com/office/drawing/2014/main" id="{ED2382D5-150F-5922-0131-A3C3DB5F901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5297" y="398297"/>
            <a:ext cx="3122715" cy="2867661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图片 3" descr="图表, 散点图, 箱线图&#10;&#10;描述已自动生成">
            <a:extLst>
              <a:ext uri="{FF2B5EF4-FFF2-40B4-BE49-F238E27FC236}">
                <a16:creationId xmlns:a16="http://schemas.microsoft.com/office/drawing/2014/main" id="{20AB0B68-FB45-AEF1-2D34-B4613CBF53A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15409" y="398297"/>
            <a:ext cx="3389151" cy="3112455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图片 4" descr="图表&#10;&#10;描述已自动生成">
            <a:extLst>
              <a:ext uri="{FF2B5EF4-FFF2-40B4-BE49-F238E27FC236}">
                <a16:creationId xmlns:a16="http://schemas.microsoft.com/office/drawing/2014/main" id="{8D503BE3-BF4F-F538-FA83-9C4BF73D7F3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07535" y="3429362"/>
            <a:ext cx="3300477" cy="3030341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图片 5" descr="图表&#10;&#10;描述已自动生成">
            <a:extLst>
              <a:ext uri="{FF2B5EF4-FFF2-40B4-BE49-F238E27FC236}">
                <a16:creationId xmlns:a16="http://schemas.microsoft.com/office/drawing/2014/main" id="{63C91029-B24F-4138-99B0-44AB45332CBB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1" y="3793639"/>
            <a:ext cx="3108560" cy="285485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5477391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F352D496-B0AA-4414-8890-1239B692F3E5}"/>
              </a:ext>
            </a:extLst>
          </p:cNvPr>
          <p:cNvSpPr txBox="1"/>
          <p:nvPr/>
        </p:nvSpPr>
        <p:spPr>
          <a:xfrm>
            <a:off x="0" y="0"/>
            <a:ext cx="60960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Exposure: </a:t>
            </a:r>
            <a:r>
              <a:rPr lang="en-US" altLang="zh-CN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M15 </a:t>
            </a:r>
            <a:r>
              <a:rPr lang="en-US" altLang="zh-CN" sz="1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Polyarthrosis</a:t>
            </a:r>
            <a:r>
              <a:rPr lang="en-US" altLang="zh-CN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</a:t>
            </a:r>
            <a:r>
              <a:rPr lang="en-US" altLang="zh-CN" sz="11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, outcome: knee pain</a:t>
            </a:r>
            <a:endParaRPr lang="zh-CN" altLang="en-US" sz="1100" dirty="0"/>
          </a:p>
        </p:txBody>
      </p:sp>
      <p:pic>
        <p:nvPicPr>
          <p:cNvPr id="3" name="图片 2" descr="图表&#10;&#10;描述已自动生成">
            <a:extLst>
              <a:ext uri="{FF2B5EF4-FFF2-40B4-BE49-F238E27FC236}">
                <a16:creationId xmlns:a16="http://schemas.microsoft.com/office/drawing/2014/main" id="{F1F60DDE-2D42-F1D4-07B6-A19E8B1B25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7036" y="263092"/>
            <a:ext cx="3392143" cy="3055736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图片 3" descr="图表, 箱线图&#10;&#10;描述已自动生成">
            <a:extLst>
              <a:ext uri="{FF2B5EF4-FFF2-40B4-BE49-F238E27FC236}">
                <a16:creationId xmlns:a16="http://schemas.microsoft.com/office/drawing/2014/main" id="{2A632CAF-9468-3C8F-3BD8-9475A3CC7E8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10868" y="130805"/>
            <a:ext cx="3282751" cy="2957961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图片 4" descr="图表, 散点图&#10;&#10;描述已自动生成">
            <a:extLst>
              <a:ext uri="{FF2B5EF4-FFF2-40B4-BE49-F238E27FC236}">
                <a16:creationId xmlns:a16="http://schemas.microsoft.com/office/drawing/2014/main" id="{08B17E2A-6159-373F-AED7-10D4B1DBB68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7036" y="3539173"/>
            <a:ext cx="3185460" cy="2870351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图片 5" descr="图表, 散点图&#10;&#10;描述已自动生成">
            <a:extLst>
              <a:ext uri="{FF2B5EF4-FFF2-40B4-BE49-F238E27FC236}">
                <a16:creationId xmlns:a16="http://schemas.microsoft.com/office/drawing/2014/main" id="{D2034701-F44E-3520-0E95-2031AFC6694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95160" y="3219571"/>
            <a:ext cx="3386819" cy="3051864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1093646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1F637854-A843-8D9B-E589-04C19C86567D}"/>
              </a:ext>
            </a:extLst>
          </p:cNvPr>
          <p:cNvSpPr txBox="1"/>
          <p:nvPr/>
        </p:nvSpPr>
        <p:spPr>
          <a:xfrm>
            <a:off x="0" y="0"/>
            <a:ext cx="60960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Exposure: knee pain, outcome: </a:t>
            </a:r>
            <a:r>
              <a:rPr lang="en-US" altLang="zh-CN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other specific joint derangements</a:t>
            </a:r>
            <a:endParaRPr lang="zh-CN" altLang="en-US" sz="1100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C5541C76-7D08-91D0-C6A2-8EA10711193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6514" y="428620"/>
            <a:ext cx="3324727" cy="3052878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图片 3" descr="图表&#10;&#10;描述已自动生成">
            <a:extLst>
              <a:ext uri="{FF2B5EF4-FFF2-40B4-BE49-F238E27FC236}">
                <a16:creationId xmlns:a16="http://schemas.microsoft.com/office/drawing/2014/main" id="{559D0019-5EB2-D1EE-D8C8-9761B1DFAC2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74158" y="3635002"/>
            <a:ext cx="3397083" cy="3119548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图片 4" descr="图表, 散点图&#10;&#10;描述已自动生成">
            <a:extLst>
              <a:ext uri="{FF2B5EF4-FFF2-40B4-BE49-F238E27FC236}">
                <a16:creationId xmlns:a16="http://schemas.microsoft.com/office/drawing/2014/main" id="{2A7DDF18-6520-55EE-810D-A64C0FAE71A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56517" y="3710350"/>
            <a:ext cx="3315387" cy="3044200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6" name="组合 5">
            <a:extLst>
              <a:ext uri="{FF2B5EF4-FFF2-40B4-BE49-F238E27FC236}">
                <a16:creationId xmlns:a16="http://schemas.microsoft.com/office/drawing/2014/main" id="{8EB5F698-3118-79B5-5C86-928905EC3E0E}"/>
              </a:ext>
            </a:extLst>
          </p:cNvPr>
          <p:cNvGrpSpPr/>
          <p:nvPr/>
        </p:nvGrpSpPr>
        <p:grpSpPr>
          <a:xfrm>
            <a:off x="5854995" y="261610"/>
            <a:ext cx="3717272" cy="3350693"/>
            <a:chOff x="0" y="0"/>
            <a:chExt cx="4408170" cy="4048125"/>
          </a:xfrm>
        </p:grpSpPr>
        <p:pic>
          <p:nvPicPr>
            <p:cNvPr id="7" name="图片 6" descr="图表, 散点图&#10;&#10;描述已自动生成">
              <a:extLst>
                <a:ext uri="{FF2B5EF4-FFF2-40B4-BE49-F238E27FC236}">
                  <a16:creationId xmlns:a16="http://schemas.microsoft.com/office/drawing/2014/main" id="{DAA3AA79-1F78-B99E-0C78-6D1A2B6852B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4408170" cy="404812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8" name="矩形: 圆角 7">
              <a:extLst>
                <a:ext uri="{FF2B5EF4-FFF2-40B4-BE49-F238E27FC236}">
                  <a16:creationId xmlns:a16="http://schemas.microsoft.com/office/drawing/2014/main" id="{1CEE013F-4A34-8837-6F83-D6E35E46A33F}"/>
                </a:ext>
              </a:extLst>
            </p:cNvPr>
            <p:cNvSpPr/>
            <p:nvPr/>
          </p:nvSpPr>
          <p:spPr>
            <a:xfrm>
              <a:off x="2396918" y="568119"/>
              <a:ext cx="1694366" cy="326156"/>
            </a:xfrm>
            <a:prstGeom prst="roundRect">
              <a:avLst/>
            </a:prstGeom>
            <a:noFill/>
            <a:ln w="9525" cap="flat" cmpd="sng" algn="ctr">
              <a:solidFill>
                <a:schemeClr val="accent2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accent2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404652912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8272D0D4-FD5F-B36E-0312-ABFE07D9DE3A}"/>
              </a:ext>
            </a:extLst>
          </p:cNvPr>
          <p:cNvSpPr txBox="1"/>
          <p:nvPr/>
        </p:nvSpPr>
        <p:spPr>
          <a:xfrm>
            <a:off x="0" y="0"/>
            <a:ext cx="60960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Exposure: </a:t>
            </a:r>
            <a:r>
              <a:rPr lang="en-US" altLang="zh-CN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other specific joint derangements</a:t>
            </a:r>
            <a:r>
              <a:rPr lang="en-US" altLang="zh-CN" sz="11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, outcome: knee pain</a:t>
            </a:r>
            <a:endParaRPr lang="zh-CN" altLang="en-US" sz="1100" dirty="0"/>
          </a:p>
        </p:txBody>
      </p:sp>
      <p:pic>
        <p:nvPicPr>
          <p:cNvPr id="3" name="图片 2" descr="图表&#10;&#10;描述已自动生成">
            <a:extLst>
              <a:ext uri="{FF2B5EF4-FFF2-40B4-BE49-F238E27FC236}">
                <a16:creationId xmlns:a16="http://schemas.microsoft.com/office/drawing/2014/main" id="{236761C0-1B89-C373-E55E-D2B6BC2E881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84625" y="470244"/>
            <a:ext cx="3376958" cy="3042818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图片 3" descr="图表&#10;&#10;描述已自动生成">
            <a:extLst>
              <a:ext uri="{FF2B5EF4-FFF2-40B4-BE49-F238E27FC236}">
                <a16:creationId xmlns:a16="http://schemas.microsoft.com/office/drawing/2014/main" id="{7320E3B2-E190-7EEF-D06A-A630A7BEF9D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73972" y="450373"/>
            <a:ext cx="3399443" cy="3062689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图片 4" descr="表格&#10;&#10;描述已自动生成">
            <a:extLst>
              <a:ext uri="{FF2B5EF4-FFF2-40B4-BE49-F238E27FC236}">
                <a16:creationId xmlns:a16="http://schemas.microsoft.com/office/drawing/2014/main" id="{C6C826EB-2621-090F-E2A5-BB90EE92CA8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03343" y="3800224"/>
            <a:ext cx="3314998" cy="2986705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图片 5" descr="图表, 散点图&#10;&#10;描述已自动生成">
            <a:extLst>
              <a:ext uri="{FF2B5EF4-FFF2-40B4-BE49-F238E27FC236}">
                <a16:creationId xmlns:a16="http://schemas.microsoft.com/office/drawing/2014/main" id="{BEFAAFAC-16C3-DC13-20BC-41C5F6017DE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15740" y="3723928"/>
            <a:ext cx="3399443" cy="3063001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61262270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75C95907-314B-E1D3-D08C-00915BDC0A07}"/>
              </a:ext>
            </a:extLst>
          </p:cNvPr>
          <p:cNvSpPr txBox="1"/>
          <p:nvPr/>
        </p:nvSpPr>
        <p:spPr>
          <a:xfrm>
            <a:off x="0" y="0"/>
            <a:ext cx="60960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Exposure: knee pain, outcome: </a:t>
            </a:r>
            <a:r>
              <a:rPr lang="en-US" altLang="zh-CN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osteoarthritis</a:t>
            </a:r>
            <a:endParaRPr lang="zh-CN" altLang="en-US" sz="1100" dirty="0"/>
          </a:p>
        </p:txBody>
      </p:sp>
      <p:pic>
        <p:nvPicPr>
          <p:cNvPr id="3" name="图片 2" descr="图表, 箱线图&#10;&#10;描述已自动生成">
            <a:extLst>
              <a:ext uri="{FF2B5EF4-FFF2-40B4-BE49-F238E27FC236}">
                <a16:creationId xmlns:a16="http://schemas.microsoft.com/office/drawing/2014/main" id="{0DD9418D-2859-54D9-C88A-9A6B2488926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4693" y="198373"/>
            <a:ext cx="3590312" cy="3296667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B02D4A85-DED0-5075-585A-2A1C4D4CEFD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41079" y="464166"/>
            <a:ext cx="3300443" cy="3030874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图片 4" descr="图表&#10;&#10;描述已自动生成">
            <a:extLst>
              <a:ext uri="{FF2B5EF4-FFF2-40B4-BE49-F238E27FC236}">
                <a16:creationId xmlns:a16="http://schemas.microsoft.com/office/drawing/2014/main" id="{C560987C-C355-4F00-B45A-38E500DE290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09057" y="3599210"/>
            <a:ext cx="3323576" cy="3052119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图片 5" descr="图表, 直方图&#10;&#10;描述已自动生成">
            <a:extLst>
              <a:ext uri="{FF2B5EF4-FFF2-40B4-BE49-F238E27FC236}">
                <a16:creationId xmlns:a16="http://schemas.microsoft.com/office/drawing/2014/main" id="{FE977E39-EAE9-C725-E5DF-D2141348DD7A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01151" y="3599210"/>
            <a:ext cx="3377395" cy="310169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85531306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83CC6F62-B555-DF0D-B810-83F612379BA2}"/>
              </a:ext>
            </a:extLst>
          </p:cNvPr>
          <p:cNvSpPr txBox="1"/>
          <p:nvPr/>
        </p:nvSpPr>
        <p:spPr>
          <a:xfrm>
            <a:off x="0" y="0"/>
            <a:ext cx="60960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Exposure: </a:t>
            </a:r>
            <a:r>
              <a:rPr lang="en-US" altLang="zh-CN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osteoarthritis</a:t>
            </a:r>
            <a:r>
              <a:rPr lang="en-US" altLang="zh-CN" sz="11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, outcome: knee pain</a:t>
            </a:r>
            <a:endParaRPr lang="zh-CN" altLang="en-US" sz="1100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4BC6459-0162-D148-4498-86F8B2C3A8D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8544" y="346671"/>
            <a:ext cx="3371172" cy="3037649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图片 3" descr="图表&#10;&#10;描述已自动生成">
            <a:extLst>
              <a:ext uri="{FF2B5EF4-FFF2-40B4-BE49-F238E27FC236}">
                <a16:creationId xmlns:a16="http://schemas.microsoft.com/office/drawing/2014/main" id="{9D89EFBB-27A9-4FEE-D01E-3B03864B814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52758" y="401296"/>
            <a:ext cx="3282521" cy="2957623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图片 4" descr="图表, 散点图&#10;&#10;描述已自动生成">
            <a:extLst>
              <a:ext uri="{FF2B5EF4-FFF2-40B4-BE49-F238E27FC236}">
                <a16:creationId xmlns:a16="http://schemas.microsoft.com/office/drawing/2014/main" id="{678BAF52-F55E-2D1F-B5B3-493F95AE23F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8056" y="3553706"/>
            <a:ext cx="3282521" cy="2957623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图片 5" descr="图表, 散点图&#10;&#10;描述已自动生成">
            <a:extLst>
              <a:ext uri="{FF2B5EF4-FFF2-40B4-BE49-F238E27FC236}">
                <a16:creationId xmlns:a16="http://schemas.microsoft.com/office/drawing/2014/main" id="{3D2C6E66-DA19-EC97-BC05-8BB68C2F9EA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06393" y="3499082"/>
            <a:ext cx="3312231" cy="2984458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41415381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78</Words>
  <Application>Microsoft Office PowerPoint</Application>
  <PresentationFormat>宽屏</PresentationFormat>
  <Paragraphs>8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2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Eureka Li</dc:creator>
  <cp:lastModifiedBy>Eureka Li</cp:lastModifiedBy>
  <cp:revision>1</cp:revision>
  <dcterms:created xsi:type="dcterms:W3CDTF">2024-08-30T09:59:28Z</dcterms:created>
  <dcterms:modified xsi:type="dcterms:W3CDTF">2024-08-30T10:11:49Z</dcterms:modified>
</cp:coreProperties>
</file>